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CDK4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1513450439107125"/>
          <c:y val="4.0842559869221501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2:$A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D$2:$D$5</c:f>
              <c:numCache>
                <c:formatCode>General</c:formatCode>
                <c:ptCount val="4"/>
                <c:pt idx="0">
                  <c:v>1</c:v>
                </c:pt>
                <c:pt idx="1">
                  <c:v>0.3635979285636049</c:v>
                </c:pt>
                <c:pt idx="2">
                  <c:v>0.1434508569531863</c:v>
                </c:pt>
                <c:pt idx="3">
                  <c:v>9.859825163412562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48963648"/>
        <c:axId val="248964208"/>
      </c:barChart>
      <c:catAx>
        <c:axId val="248963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64208"/>
        <c:crosses val="autoZero"/>
        <c:auto val="1"/>
        <c:lblAlgn val="ctr"/>
        <c:lblOffset val="100"/>
        <c:noMultiLvlLbl val="0"/>
      </c:catAx>
      <c:valAx>
        <c:axId val="248964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636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inD1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692905844580223"/>
          <c:y val="3.4364261168384883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4824369411450689"/>
          <c:y val="0.25491408934707904"/>
          <c:w val="0.7896094132301259"/>
          <c:h val="0.585647644559893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2:$A$5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E$2:$E$5</c:f>
              <c:numCache>
                <c:formatCode>General</c:formatCode>
                <c:ptCount val="4"/>
                <c:pt idx="0">
                  <c:v>1</c:v>
                </c:pt>
                <c:pt idx="1">
                  <c:v>1.084417129600727</c:v>
                </c:pt>
                <c:pt idx="2">
                  <c:v>0.47618894658100502</c:v>
                </c:pt>
                <c:pt idx="3">
                  <c:v>0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48966448"/>
        <c:axId val="248967008"/>
      </c:barChart>
      <c:catAx>
        <c:axId val="248966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67008"/>
        <c:crosses val="autoZero"/>
        <c:auto val="1"/>
        <c:lblAlgn val="ctr"/>
        <c:lblOffset val="100"/>
        <c:noMultiLvlLbl val="0"/>
      </c:catAx>
      <c:valAx>
        <c:axId val="248967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664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-CDK4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2393889538168283"/>
          <c:y val="3.789694815180264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1:$A$1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D$11:$D$14</c:f>
              <c:numCache>
                <c:formatCode>General</c:formatCode>
                <c:ptCount val="4"/>
                <c:pt idx="0">
                  <c:v>1</c:v>
                </c:pt>
                <c:pt idx="1">
                  <c:v>0.41067191995407365</c:v>
                </c:pt>
                <c:pt idx="2">
                  <c:v>0.34369089568528521</c:v>
                </c:pt>
                <c:pt idx="3">
                  <c:v>6.661025025711893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48969248"/>
        <c:axId val="248969808"/>
      </c:barChart>
      <c:catAx>
        <c:axId val="248969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69808"/>
        <c:crosses val="autoZero"/>
        <c:auto val="1"/>
        <c:lblAlgn val="ctr"/>
        <c:lblOffset val="100"/>
        <c:noMultiLvlLbl val="0"/>
      </c:catAx>
      <c:valAx>
        <c:axId val="248969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692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clinD1</a:t>
            </a:r>
          </a:p>
        </c:rich>
      </c:tx>
      <c:layout>
        <c:manualLayout>
          <c:xMode val="edge"/>
          <c:yMode val="edge"/>
          <c:x val="0.34731963821765105"/>
          <c:y val="4.9751645365937298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1:$A$1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E$11:$E$14</c:f>
              <c:numCache>
                <c:formatCode>General</c:formatCode>
                <c:ptCount val="4"/>
                <c:pt idx="0">
                  <c:v>1</c:v>
                </c:pt>
                <c:pt idx="1">
                  <c:v>1.2217432681816918</c:v>
                </c:pt>
                <c:pt idx="2">
                  <c:v>0.79306385805810742</c:v>
                </c:pt>
                <c:pt idx="3">
                  <c:v>0.297074073159828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48972048"/>
        <c:axId val="248972608"/>
      </c:barChart>
      <c:catAx>
        <c:axId val="248972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72608"/>
        <c:crosses val="autoZero"/>
        <c:auto val="1"/>
        <c:lblAlgn val="ctr"/>
        <c:lblOffset val="100"/>
        <c:noMultiLvlLbl val="0"/>
      </c:catAx>
      <c:valAx>
        <c:axId val="248972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720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-CDK4</a:t>
            </a:r>
            <a:endParaRPr lang="zh-CN" altLang="zh-CN" sz="1400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0462429591576587"/>
          <c:y val="3.9603960396039604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21:$A$2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D$21:$D$24</c:f>
              <c:numCache>
                <c:formatCode>General</c:formatCode>
                <c:ptCount val="4"/>
                <c:pt idx="0">
                  <c:v>1</c:v>
                </c:pt>
                <c:pt idx="1">
                  <c:v>0.79214138839316806</c:v>
                </c:pt>
                <c:pt idx="2">
                  <c:v>0.73752277947840006</c:v>
                </c:pt>
                <c:pt idx="3">
                  <c:v>0.243131449245736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48974848"/>
        <c:axId val="248975408"/>
      </c:barChart>
      <c:catAx>
        <c:axId val="248974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75408"/>
        <c:crosses val="autoZero"/>
        <c:auto val="1"/>
        <c:lblAlgn val="ctr"/>
        <c:lblOffset val="100"/>
        <c:noMultiLvlLbl val="0"/>
      </c:catAx>
      <c:valAx>
        <c:axId val="248975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489748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yclinD1</a:t>
            </a:r>
            <a:endParaRPr lang="zh-CN" altLang="zh-CN" sz="1400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2493590426003797"/>
          <c:y val="3.3840947546531303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21:$A$2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E$21:$E$24</c:f>
              <c:numCache>
                <c:formatCode>General</c:formatCode>
                <c:ptCount val="4"/>
                <c:pt idx="0">
                  <c:v>1</c:v>
                </c:pt>
                <c:pt idx="1">
                  <c:v>0.91185533133055185</c:v>
                </c:pt>
                <c:pt idx="2">
                  <c:v>0.62247884082584082</c:v>
                </c:pt>
                <c:pt idx="3">
                  <c:v>0.478199626715096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0775520"/>
        <c:axId val="250776080"/>
      </c:barChart>
      <c:catAx>
        <c:axId val="250775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0776080"/>
        <c:crosses val="autoZero"/>
        <c:auto val="1"/>
        <c:lblAlgn val="ctr"/>
        <c:lblOffset val="100"/>
        <c:noMultiLvlLbl val="0"/>
      </c:catAx>
      <c:valAx>
        <c:axId val="250776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07755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-CDK4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1261326986109764"/>
          <c:y val="4.7968666015791542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31:$A$3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D$31:$D$34</c:f>
              <c:numCache>
                <c:formatCode>General</c:formatCode>
                <c:ptCount val="4"/>
                <c:pt idx="0">
                  <c:v>1</c:v>
                </c:pt>
                <c:pt idx="1">
                  <c:v>0.48596763962359646</c:v>
                </c:pt>
                <c:pt idx="2">
                  <c:v>0.23327073793779513</c:v>
                </c:pt>
                <c:pt idx="3">
                  <c:v>0.198970517389615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0778320"/>
        <c:axId val="250778880"/>
      </c:barChart>
      <c:catAx>
        <c:axId val="25077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0778880"/>
        <c:crosses val="autoZero"/>
        <c:auto val="1"/>
        <c:lblAlgn val="ctr"/>
        <c:lblOffset val="100"/>
        <c:noMultiLvlLbl val="0"/>
      </c:catAx>
      <c:valAx>
        <c:axId val="250778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07783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yclinD1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637615419294153"/>
          <c:y val="2.1739130434782608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31:$A$3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E$31:$E$34</c:f>
              <c:numCache>
                <c:formatCode>General</c:formatCode>
                <c:ptCount val="4"/>
                <c:pt idx="0">
                  <c:v>1</c:v>
                </c:pt>
                <c:pt idx="1">
                  <c:v>0.81036436391379729</c:v>
                </c:pt>
                <c:pt idx="2">
                  <c:v>0.58864862048795674</c:v>
                </c:pt>
                <c:pt idx="3">
                  <c:v>0.499478781572627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0781120"/>
        <c:axId val="250781680"/>
      </c:barChart>
      <c:catAx>
        <c:axId val="250781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0781680"/>
        <c:crosses val="autoZero"/>
        <c:auto val="1"/>
        <c:lblAlgn val="ctr"/>
        <c:lblOffset val="100"/>
        <c:noMultiLvlLbl val="0"/>
      </c:catAx>
      <c:valAx>
        <c:axId val="250781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07811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136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2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0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6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04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21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85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0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93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54"/>
          <p:cNvGrpSpPr/>
          <p:nvPr/>
        </p:nvGrpSpPr>
        <p:grpSpPr>
          <a:xfrm>
            <a:off x="1840917" y="250775"/>
            <a:ext cx="9338139" cy="5971436"/>
            <a:chOff x="1840917" y="250775"/>
            <a:chExt cx="9338139" cy="5971436"/>
          </a:xfrm>
        </p:grpSpPr>
        <p:sp>
          <p:nvSpPr>
            <p:cNvPr id="2" name="TextBox 1"/>
            <p:cNvSpPr txBox="1"/>
            <p:nvPr/>
          </p:nvSpPr>
          <p:spPr>
            <a:xfrm>
              <a:off x="1840917" y="250775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2056526" y="845648"/>
              <a:ext cx="2075462" cy="2138578"/>
              <a:chOff x="2056526" y="1003778"/>
              <a:chExt cx="2075462" cy="1980448"/>
            </a:xfrm>
          </p:grpSpPr>
          <p:graphicFrame>
            <p:nvGraphicFramePr>
              <p:cNvPr id="3" name="图表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21110806"/>
                  </p:ext>
                </p:extLst>
              </p:nvPr>
            </p:nvGraphicFramePr>
            <p:xfrm>
              <a:off x="2234615" y="1003778"/>
              <a:ext cx="1897373" cy="198044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TextBox 3"/>
              <p:cNvSpPr txBox="1"/>
              <p:nvPr/>
            </p:nvSpPr>
            <p:spPr>
              <a:xfrm rot="5400000" flipV="1">
                <a:off x="1613888" y="1647235"/>
                <a:ext cx="1127319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4349644" y="954074"/>
              <a:ext cx="1933938" cy="2118489"/>
              <a:chOff x="4521864" y="934757"/>
              <a:chExt cx="1933938" cy="2118489"/>
            </a:xfrm>
          </p:grpSpPr>
          <p:graphicFrame>
            <p:nvGraphicFramePr>
              <p:cNvPr id="6" name="图表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13324422"/>
                  </p:ext>
                </p:extLst>
              </p:nvPr>
            </p:nvGraphicFramePr>
            <p:xfrm>
              <a:off x="4772670" y="934757"/>
              <a:ext cx="1683132" cy="21184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 rot="5400000" flipV="1">
                <a:off x="4034221" y="1647544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1850296" y="67707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26590" y="707148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2234615" y="3141313"/>
              <a:ext cx="36782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3980368" y="3153719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-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6834132" y="1062501"/>
              <a:ext cx="2029045" cy="2108115"/>
              <a:chOff x="7204334" y="1062501"/>
              <a:chExt cx="2029045" cy="2108115"/>
            </a:xfrm>
          </p:grpSpPr>
          <p:graphicFrame>
            <p:nvGraphicFramePr>
              <p:cNvPr id="24" name="图表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87701988"/>
                  </p:ext>
                </p:extLst>
              </p:nvPr>
            </p:nvGraphicFramePr>
            <p:xfrm>
              <a:off x="7378331" y="1062501"/>
              <a:ext cx="1855048" cy="210811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5" name="TextBox 24"/>
              <p:cNvSpPr txBox="1"/>
              <p:nvPr/>
            </p:nvSpPr>
            <p:spPr>
              <a:xfrm rot="5400000" flipV="1">
                <a:off x="6716691" y="1738068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26" name="TextBox 25"/>
            <p:cNvSpPr txBox="1"/>
            <p:nvPr/>
          </p:nvSpPr>
          <p:spPr>
            <a:xfrm>
              <a:off x="6554823" y="707147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9037174" y="984146"/>
              <a:ext cx="1945835" cy="2169801"/>
              <a:chOff x="9432601" y="1062501"/>
              <a:chExt cx="1945835" cy="2169801"/>
            </a:xfrm>
          </p:grpSpPr>
          <p:graphicFrame>
            <p:nvGraphicFramePr>
              <p:cNvPr id="28" name="图表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93635082"/>
                  </p:ext>
                </p:extLst>
              </p:nvPr>
            </p:nvGraphicFramePr>
            <p:xfrm>
              <a:off x="9607537" y="1062501"/>
              <a:ext cx="1770899" cy="21698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9" name="TextBox 28"/>
              <p:cNvSpPr txBox="1"/>
              <p:nvPr/>
            </p:nvSpPr>
            <p:spPr>
              <a:xfrm rot="5400000" flipV="1">
                <a:off x="8944958" y="1783464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31" name="TextBox 30"/>
            <p:cNvSpPr txBox="1"/>
            <p:nvPr/>
          </p:nvSpPr>
          <p:spPr>
            <a:xfrm>
              <a:off x="8739427" y="73994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Straight Connector 31"/>
            <p:cNvCxnSpPr/>
            <p:nvPr/>
          </p:nvCxnSpPr>
          <p:spPr>
            <a:xfrm>
              <a:off x="7195588" y="3118307"/>
              <a:ext cx="36782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8949057" y="3151106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266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2024547" y="3824206"/>
              <a:ext cx="2049181" cy="2079361"/>
              <a:chOff x="2024547" y="3824206"/>
              <a:chExt cx="2049181" cy="2079361"/>
            </a:xfrm>
          </p:grpSpPr>
          <p:graphicFrame>
            <p:nvGraphicFramePr>
              <p:cNvPr id="34" name="图表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91490848"/>
                  </p:ext>
                </p:extLst>
              </p:nvPr>
            </p:nvGraphicFramePr>
            <p:xfrm>
              <a:off x="2194869" y="3824206"/>
              <a:ext cx="1878859" cy="207936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35" name="TextBox 34"/>
              <p:cNvSpPr txBox="1"/>
              <p:nvPr/>
            </p:nvSpPr>
            <p:spPr>
              <a:xfrm rot="5400000" flipV="1">
                <a:off x="1536904" y="4495917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4356469" y="3845808"/>
              <a:ext cx="1975188" cy="2036156"/>
              <a:chOff x="4429416" y="3845808"/>
              <a:chExt cx="1975188" cy="2036156"/>
            </a:xfrm>
          </p:grpSpPr>
          <p:graphicFrame>
            <p:nvGraphicFramePr>
              <p:cNvPr id="37" name="图表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87588773"/>
                  </p:ext>
                </p:extLst>
              </p:nvPr>
            </p:nvGraphicFramePr>
            <p:xfrm>
              <a:off x="4591688" y="3845808"/>
              <a:ext cx="1812916" cy="20361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38" name="TextBox 37"/>
              <p:cNvSpPr txBox="1"/>
              <p:nvPr/>
            </p:nvSpPr>
            <p:spPr>
              <a:xfrm rot="5400000" flipV="1">
                <a:off x="3941773" y="4495918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1884925" y="3620879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244050" y="3620880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Straight Connector 41"/>
            <p:cNvCxnSpPr/>
            <p:nvPr/>
          </p:nvCxnSpPr>
          <p:spPr>
            <a:xfrm>
              <a:off x="2234615" y="5903567"/>
              <a:ext cx="36782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3934136" y="5945212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.1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7" name="Group 46"/>
            <p:cNvGrpSpPr/>
            <p:nvPr/>
          </p:nvGrpSpPr>
          <p:grpSpPr>
            <a:xfrm>
              <a:off x="6786700" y="3845808"/>
              <a:ext cx="2073749" cy="2087446"/>
              <a:chOff x="6786700" y="3845808"/>
              <a:chExt cx="2073749" cy="2087446"/>
            </a:xfrm>
          </p:grpSpPr>
          <p:graphicFrame>
            <p:nvGraphicFramePr>
              <p:cNvPr id="45" name="图表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65031182"/>
                  </p:ext>
                </p:extLst>
              </p:nvPr>
            </p:nvGraphicFramePr>
            <p:xfrm>
              <a:off x="6955154" y="3845808"/>
              <a:ext cx="1905295" cy="208744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46" name="TextBox 45"/>
              <p:cNvSpPr txBox="1"/>
              <p:nvPr/>
            </p:nvSpPr>
            <p:spPr>
              <a:xfrm rot="5400000" flipV="1">
                <a:off x="6299057" y="4503019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9212110" y="3897878"/>
              <a:ext cx="1966946" cy="1938367"/>
              <a:chOff x="9212110" y="3897878"/>
              <a:chExt cx="1966946" cy="1938367"/>
            </a:xfrm>
          </p:grpSpPr>
          <p:graphicFrame>
            <p:nvGraphicFramePr>
              <p:cNvPr id="48" name="图表 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70971029"/>
                  </p:ext>
                </p:extLst>
              </p:nvPr>
            </p:nvGraphicFramePr>
            <p:xfrm>
              <a:off x="9382346" y="3897878"/>
              <a:ext cx="1796710" cy="193836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49" name="TextBox 48"/>
              <p:cNvSpPr txBox="1"/>
              <p:nvPr/>
            </p:nvSpPr>
            <p:spPr>
              <a:xfrm rot="5400000" flipV="1">
                <a:off x="8724467" y="4522783"/>
                <a:ext cx="1217330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>
              <a:off x="6590792" y="365359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870835" y="364870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3" name="Straight Connector 52"/>
            <p:cNvCxnSpPr/>
            <p:nvPr/>
          </p:nvCxnSpPr>
          <p:spPr>
            <a:xfrm>
              <a:off x="7179359" y="5903567"/>
              <a:ext cx="36782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8995539" y="5933254"/>
              <a:ext cx="6751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.1R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62082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38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Ping</dc:creator>
  <cp:lastModifiedBy>Fan,Ping</cp:lastModifiedBy>
  <cp:revision>29</cp:revision>
  <dcterms:created xsi:type="dcterms:W3CDTF">2018-03-12T14:59:56Z</dcterms:created>
  <dcterms:modified xsi:type="dcterms:W3CDTF">2018-03-13T17:07:34Z</dcterms:modified>
</cp:coreProperties>
</file>